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8E66B-02EB-24F0-EC2F-11A50709A6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EB598C-92F7-699E-EC3D-40E98FFE4F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8A83A6-F073-8030-9D08-C79C839C0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116BC-4F0B-DF11-A4D1-2EF6FC71B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33460-7488-1DDF-42C8-BB7B6F18B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471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CC94A-9C5B-7AF9-00F9-93A426DD63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A58460-BFD0-2E08-414C-F4F3EED10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7C98AA-AD4E-D463-BA8E-B0A4A50A8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D6A36D-0D87-5D26-028E-137BE6D63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D5E68-C1D2-7260-B628-22CDC1545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34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2DE5B2-E2BD-A5ED-D714-EF56E6B41F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30D85F-C0C8-094B-A592-B4FD5F2614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CF949F-8872-473E-8D57-BF28B3120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2586E0-6D69-9349-7AC9-47C9AF5CA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248515-9020-6EF2-463D-70D39DED8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69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1A5A89-12F0-8316-91D9-66CC18C05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1E8E1-15BE-7273-0457-31AD1326E8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C5BA41-26E0-8949-C11C-C66CCC300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E0B85-7A43-75FA-47A0-6019780D1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135443-FC7A-7B90-3EBC-2103C3628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464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B32D95-3BDF-0EE7-2955-003C647231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AAB82-F317-C710-3F5E-62C5EF75D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D9D4C8-8A13-2818-5BB4-0312FD96E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CDE9C1-3204-4515-6464-B36706EF6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4CBA7-AE7A-F96B-482B-039530176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24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C1A18F-CCC0-A453-EFF2-0A3B45CC2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AACF41-0926-245B-D993-92ADB4B02E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D0773F-2482-3C2C-552D-EE070869AC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0089A2-1BD1-C4F6-6B8B-B1D4D0554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64097D-9E61-28CF-CC06-77E72EF70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1415C3-7CF4-6505-5B80-D9440600B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492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096A3-392A-A79F-EBD8-4572CE6BC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819241-2AC4-83E0-69A2-624B473B41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83E3B7-3B57-2C22-14AF-27F561DA26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DA6F02-4EC2-5E60-68A4-8DD6A0E6F1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C2D831-AC62-F85C-8612-01D40FAEEB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9C8D84-1473-B611-88DC-51BCE62BA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A52257-2916-F8C0-1738-8D9652217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37AC04-600F-D9E1-39ED-354E4989A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823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96283-81E7-2761-F652-6A1CF30D1F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141702-A1FB-B951-5F9F-9049C0866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860A54-94EB-BB4F-6FA8-394EEB24C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DF0556-00F4-4E69-D042-572245C2B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304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78646A-8C6B-5303-2708-92BBF232E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AD4F54-91BC-2604-782C-73E4BCA84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A29DA8-CB34-66A2-CA81-BFC8F2A94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406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6F41A-433A-AF41-9E75-345D35E26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3BEEFC-2FF3-29BE-F6D9-4EE541B98B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AA3B45-54FF-CCA6-F13A-60006269F2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6585A1-5374-90CC-76F7-D166F60EE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78F38C-0652-4ACD-086F-B855EF9FF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B23200-CD4E-8BCD-5524-DB7B70F9C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093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D23825-8340-98DC-8766-B47DF1E66A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FFDDEB-8435-D4A0-8C02-68F6A5508D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80FF3F-879C-4391-18F0-669975AEC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0C56FA-64D2-8F64-1DB7-E38B39E1E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B5AC21-D392-D07B-79DC-2D296803E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A6AC00-BBB2-C910-ED46-6816B9AB8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63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D28F23-02C8-728F-EEF3-B5110E9CB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B9828D-BFDA-B3B5-1202-D9029DC978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1DBAB-BFA9-35A8-5F8E-9FFA6A62BD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B7CDB4-BE81-44CC-AE1F-10D3994EA133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AB609B-95DB-DFA2-D608-D592AD820E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4DDC4C-5385-30B1-0F80-A707B7E032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3BAF98-5930-4BEB-B9E6-B389F7AA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100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>
            <a:extLst>
              <a:ext uri="{FF2B5EF4-FFF2-40B4-BE49-F238E27FC236}">
                <a16:creationId xmlns:a16="http://schemas.microsoft.com/office/drawing/2014/main" id="{AE698C09-2874-B6AF-6367-B0D7372974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168" y="2247513"/>
            <a:ext cx="2984469" cy="2354626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E8E2641-0629-81D2-5953-8058C1EAEF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02407" y="165775"/>
            <a:ext cx="2684128" cy="2117491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02614237-EA5B-8A8A-CFFD-53401F292C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2823" y="198538"/>
            <a:ext cx="2755124" cy="205196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7BB54F7B-4F9B-09BD-C743-86861C1DEB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06821" y="183279"/>
            <a:ext cx="2684128" cy="2116981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DCA7A3D3-8690-1CDF-DD65-B024E183C1F9}"/>
              </a:ext>
            </a:extLst>
          </p:cNvPr>
          <p:cNvGrpSpPr/>
          <p:nvPr/>
        </p:nvGrpSpPr>
        <p:grpSpPr>
          <a:xfrm>
            <a:off x="255169" y="196719"/>
            <a:ext cx="2975172" cy="2105888"/>
            <a:chOff x="0" y="609602"/>
            <a:chExt cx="3808805" cy="300412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BE6AEF3-D6D1-3C51-1CEC-4469CD698CC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609602"/>
              <a:ext cx="3808805" cy="3004128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765F158-4BE6-C59E-B034-CE911A2DF4B7}"/>
                </a:ext>
              </a:extLst>
            </p:cNvPr>
            <p:cNvSpPr txBox="1"/>
            <p:nvPr/>
          </p:nvSpPr>
          <p:spPr>
            <a:xfrm>
              <a:off x="1367402" y="609602"/>
              <a:ext cx="1337418" cy="439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dirty="0">
                  <a:solidFill>
                    <a:srgbClr val="FF0000"/>
                  </a:solidFill>
                  <a:latin typeface="Inter"/>
                </a:rPr>
                <a:t>Neurons</a:t>
              </a:r>
              <a:endParaRPr lang="en-US" sz="14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1ED85CD4-884F-96DD-CC60-9953C9EE8374}"/>
              </a:ext>
            </a:extLst>
          </p:cNvPr>
          <p:cNvSpPr txBox="1"/>
          <p:nvPr/>
        </p:nvSpPr>
        <p:spPr>
          <a:xfrm>
            <a:off x="3143466" y="147827"/>
            <a:ext cx="297760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Microglia/</a:t>
            </a:r>
            <a:r>
              <a:rPr lang="en-US" sz="1400" dirty="0">
                <a:solidFill>
                  <a:srgbClr val="00B050"/>
                </a:solidFill>
                <a:latin typeface="Inter"/>
              </a:rPr>
              <a:t>Macrophages</a:t>
            </a:r>
            <a:endParaRPr lang="en-US" sz="1400" dirty="0">
              <a:solidFill>
                <a:srgbClr val="00B05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D24CDD-3612-6A35-F190-5E929D4B3BE5}"/>
              </a:ext>
            </a:extLst>
          </p:cNvPr>
          <p:cNvSpPr txBox="1"/>
          <p:nvPr/>
        </p:nvSpPr>
        <p:spPr>
          <a:xfrm>
            <a:off x="6771333" y="202000"/>
            <a:ext cx="1461883" cy="2770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Oligodendrocytes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3312DAF-6048-8203-34C8-49115460A4B5}"/>
              </a:ext>
            </a:extLst>
          </p:cNvPr>
          <p:cNvSpPr txBox="1"/>
          <p:nvPr/>
        </p:nvSpPr>
        <p:spPr>
          <a:xfrm>
            <a:off x="9470847" y="200547"/>
            <a:ext cx="15337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Endothelial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7DB2F6F-DF4D-D9A2-716B-57CC6600DB63}"/>
              </a:ext>
            </a:extLst>
          </p:cNvPr>
          <p:cNvSpPr txBox="1"/>
          <p:nvPr/>
        </p:nvSpPr>
        <p:spPr>
          <a:xfrm>
            <a:off x="1228517" y="2235770"/>
            <a:ext cx="132856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Macrophages</a:t>
            </a:r>
            <a:endParaRPr lang="en-US" sz="1400" dirty="0"/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297CA031-773A-59F3-B80F-C1BD887090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26714" y="2388634"/>
            <a:ext cx="2840528" cy="2241062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3FCDB2E2-6017-07B0-0F61-8FD181C50C0D}"/>
              </a:ext>
            </a:extLst>
          </p:cNvPr>
          <p:cNvSpPr txBox="1"/>
          <p:nvPr/>
        </p:nvSpPr>
        <p:spPr>
          <a:xfrm>
            <a:off x="4035775" y="2238757"/>
            <a:ext cx="110816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Pericytes</a:t>
            </a:r>
            <a:endParaRPr lang="en-US" sz="1400" dirty="0"/>
          </a:p>
        </p:txBody>
      </p:sp>
      <p:pic>
        <p:nvPicPr>
          <p:cNvPr id="46" name="Picture 2">
            <a:extLst>
              <a:ext uri="{FF2B5EF4-FFF2-40B4-BE49-F238E27FC236}">
                <a16:creationId xmlns:a16="http://schemas.microsoft.com/office/drawing/2014/main" id="{E05348FF-A9A3-52FD-C0E1-DC76F6F0C4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67242" y="2330853"/>
            <a:ext cx="2879665" cy="2271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-3248" y="-26825"/>
            <a:ext cx="45596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6 Fig. Related to Figure 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D789D0C-4993-FE93-2EBD-DAA0CC43E023}"/>
              </a:ext>
            </a:extLst>
          </p:cNvPr>
          <p:cNvSpPr txBox="1"/>
          <p:nvPr/>
        </p:nvSpPr>
        <p:spPr>
          <a:xfrm>
            <a:off x="7080663" y="2245247"/>
            <a:ext cx="110816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FF0000"/>
                </a:solidFill>
                <a:latin typeface="Inter"/>
              </a:rPr>
              <a:t>T cells</a:t>
            </a:r>
            <a:endParaRPr lang="en-US" sz="1400" dirty="0"/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6EE400BF-37B2-4835-4807-DE237FB00A5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82744" y="4620551"/>
            <a:ext cx="6221099" cy="2271557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91A1DB51-21B7-ABB0-C590-29D8070C200F}"/>
              </a:ext>
            </a:extLst>
          </p:cNvPr>
          <p:cNvSpPr txBox="1"/>
          <p:nvPr/>
        </p:nvSpPr>
        <p:spPr>
          <a:xfrm>
            <a:off x="11180946" y="6439501"/>
            <a:ext cx="11237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rgbClr val="FF0000"/>
                </a:solidFill>
              </a:rPr>
              <a:t>LG29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5F2ACD1-4860-4CC0-2A72-2A687C915286}"/>
              </a:ext>
            </a:extLst>
          </p:cNvPr>
          <p:cNvSpPr txBox="1"/>
          <p:nvPr/>
        </p:nvSpPr>
        <p:spPr>
          <a:xfrm>
            <a:off x="156894" y="12314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C64D834-D3B8-C46E-438F-D72078373F50}"/>
              </a:ext>
            </a:extLst>
          </p:cNvPr>
          <p:cNvSpPr txBox="1"/>
          <p:nvPr/>
        </p:nvSpPr>
        <p:spPr>
          <a:xfrm>
            <a:off x="139807" y="450871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76195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Inter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10:34Z</dcterms:created>
  <dcterms:modified xsi:type="dcterms:W3CDTF">2025-07-28T20:11:10Z</dcterms:modified>
</cp:coreProperties>
</file>